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23FC2-B720-426A-98B4-4F6D97CA47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8C925-6DF1-4291-9D0D-6E313EA622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D6635-08B6-4241-83FC-A6E1C584C7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2DB03-3783-49A0-94AC-48716E35DE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410D7-DEAB-4716-AB9F-C993A06432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5F37C-8749-484E-81CE-310171D84E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BCBA7-5B9A-4F43-BC69-7E98BD3962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11B12-1E1E-4680-8EF8-36FA30FB70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71E0C-F9B8-406F-9979-FE45F3634F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55FCBF-6D6E-4ECB-AB9B-3540D9811E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7EB6A-9F17-4BD6-AAB6-E5A869D190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7359B-AF3C-4770-8F4B-3C0714205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A2D153-B3A7-4239-805B-873D620F5E0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619280" y="1125360"/>
          <a:ext cx="5481720" cy="1371600"/>
        </p:xfrm>
        <a:graphic>
          <a:graphicData uri="http://schemas.openxmlformats.org/drawingml/2006/table">
            <a:tbl>
              <a:tblPr/>
              <a:tblGrid>
                <a:gridCol w="762120"/>
                <a:gridCol w="1066680"/>
                <a:gridCol w="1143000"/>
                <a:gridCol w="1355760"/>
                <a:gridCol w="1154160"/>
              </a:tblGrid>
              <a:tr h="4572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 of Bifurca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Branch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length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ndritic Tree Area (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nd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y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79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± </a:t>
                      </a: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.0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 </a:t>
                      </a: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1.6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± </a:t>
                      </a: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.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5.3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± </a:t>
                      </a:r>
                      <a:r>
                        <a:rPr b="0" lang="he-IL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.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rd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lay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.98 ± 3.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.65 ± 7.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1.1 ± 30.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92 ± 133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80"/>
          <p:cNvSpPr/>
          <p:nvPr/>
        </p:nvSpPr>
        <p:spPr>
          <a:xfrm>
            <a:off x="3062520" y="2637000"/>
            <a:ext cx="24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 Table S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1"/>
          <p:cNvSpPr/>
          <p:nvPr/>
        </p:nvSpPr>
        <p:spPr>
          <a:xfrm>
            <a:off x="1710360" y="785880"/>
            <a:ext cx="538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orphological analysis of  IbaI+ cells in layers 2-3  in  APPsw,In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3T11:17:18Z</dcterms:created>
  <dc:creator>ronal</dc:creator>
  <dc:description/>
  <dc:language>en-US</dc:language>
  <cp:lastModifiedBy>rona</cp:lastModifiedBy>
  <dcterms:modified xsi:type="dcterms:W3CDTF">2013-06-30T18:55:14Z</dcterms:modified>
  <cp:revision>6</cp:revision>
  <dc:subject/>
  <dc:title>Slide 1</dc:title>
</cp:coreProperties>
</file>